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56" autoAdjust="0"/>
  </p:normalViewPr>
  <p:slideViewPr>
    <p:cSldViewPr>
      <p:cViewPr varScale="1">
        <p:scale>
          <a:sx n="107" d="100"/>
          <a:sy n="107" d="100"/>
        </p:scale>
        <p:origin x="-1146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C0CBD9-AC09-49EA-9CBD-FA01C4092C79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EDFF66-32FF-4C79-8D19-59A2813E822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19361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548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30330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49" y="366713"/>
            <a:ext cx="1543051" cy="780097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1" y="366713"/>
            <a:ext cx="4476751" cy="780097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1819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6899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3764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5052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238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3691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04864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0113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3819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1070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8605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1259632" y="5877272"/>
            <a:ext cx="69127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5: Fig. S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idation of microarray data by qPCR of genes differentially expressed between dwarf and normal individuals from CS x RGM_F2 population. </a:t>
            </a:r>
          </a:p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T_207s0031g0032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T_207s0031g0033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T_207s0031g0034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T_207s0031g0035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T_214s0108g00810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T_214s0108g0076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eans and standard errors shown, n = 5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Imag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1681" y="46236"/>
            <a:ext cx="5539382" cy="5759028"/>
          </a:xfrm>
          <a:prstGeom prst="rect">
            <a:avLst/>
          </a:prstGeom>
          <a:noFill/>
        </p:spPr>
      </p:pic>
      <p:sp>
        <p:nvSpPr>
          <p:cNvPr id="2" name="ZoneTexte 1"/>
          <p:cNvSpPr txBox="1"/>
          <p:nvPr/>
        </p:nvSpPr>
        <p:spPr>
          <a:xfrm>
            <a:off x="2195736" y="476672"/>
            <a:ext cx="43204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4572000" y="476672"/>
            <a:ext cx="43204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2195736" y="2132856"/>
            <a:ext cx="43204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4572000" y="2132856"/>
            <a:ext cx="43204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2195736" y="3861048"/>
            <a:ext cx="43204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4572000" y="3861048"/>
            <a:ext cx="43204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730591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1</TotalTime>
  <Words>62</Words>
  <Application>Microsoft Office PowerPoint</Application>
  <PresentationFormat>Affichage à l'écran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abine</dc:creator>
  <cp:lastModifiedBy>Sabine</cp:lastModifiedBy>
  <cp:revision>82</cp:revision>
  <dcterms:created xsi:type="dcterms:W3CDTF">2016-03-30T14:19:26Z</dcterms:created>
  <dcterms:modified xsi:type="dcterms:W3CDTF">2020-01-16T09:23:57Z</dcterms:modified>
</cp:coreProperties>
</file>